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708" r:id="rId1"/>
  </p:sldMasterIdLst>
  <p:notesMasterIdLst>
    <p:notesMasterId r:id="rId3"/>
  </p:notesMasterIdLst>
  <p:sldIdLst>
    <p:sldId id="317" r:id="rId2"/>
  </p:sldIdLst>
  <p:sldSz cx="13320713" cy="108013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52" userDrawn="1">
          <p15:clr>
            <a:srgbClr val="A4A3A4"/>
          </p15:clr>
        </p15:guide>
        <p15:guide id="2" orient="horz" pos="3379" userDrawn="1">
          <p15:clr>
            <a:srgbClr val="A4A3A4"/>
          </p15:clr>
        </p15:guide>
        <p15:guide id="3" pos="5595" userDrawn="1">
          <p15:clr>
            <a:srgbClr val="A4A3A4"/>
          </p15:clr>
        </p15:guide>
        <p15:guide id="4" pos="433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叶 雪梅" initials="叶" lastIdx="3" clrIdx="0">
    <p:extLst>
      <p:ext uri="{19B8F6BF-5375-455C-9EA6-DF929625EA0E}">
        <p15:presenceInfo xmlns:p15="http://schemas.microsoft.com/office/powerpoint/2012/main" userId="0feb727a5510bc6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5427"/>
    <a:srgbClr val="00C95E"/>
    <a:srgbClr val="7030A0"/>
    <a:srgbClr val="0000FF"/>
    <a:srgbClr val="FF33CC"/>
    <a:srgbClr val="FC726C"/>
    <a:srgbClr val="3333FF"/>
    <a:srgbClr val="E46D0A"/>
    <a:srgbClr val="CCFF33"/>
    <a:srgbClr val="2E827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51" autoAdjust="0"/>
    <p:restoredTop sz="97668" autoAdjust="0"/>
  </p:normalViewPr>
  <p:slideViewPr>
    <p:cSldViewPr>
      <p:cViewPr>
        <p:scale>
          <a:sx n="75" d="100"/>
          <a:sy n="75" d="100"/>
        </p:scale>
        <p:origin x="830" y="-720"/>
      </p:cViewPr>
      <p:guideLst>
        <p:guide orient="horz" pos="2552"/>
        <p:guide orient="horz" pos="3379"/>
        <p:guide pos="5595"/>
        <p:guide pos="4336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8B7934-86AC-4FAF-8816-D9EAB701DE84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14450" y="685800"/>
            <a:ext cx="42291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174012-3FCF-423D-89AD-F8EDE1F7B7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8597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511175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102235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533525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204470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555875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306705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578225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408940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9054" y="1767722"/>
            <a:ext cx="11322606" cy="3760470"/>
          </a:xfrm>
        </p:spPr>
        <p:txBody>
          <a:bodyPr anchor="b"/>
          <a:lstStyle>
            <a:lvl1pPr algn="ctr">
              <a:defRPr sz="874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65089" y="5673210"/>
            <a:ext cx="9990535" cy="2607825"/>
          </a:xfrm>
        </p:spPr>
        <p:txBody>
          <a:bodyPr/>
          <a:lstStyle>
            <a:lvl1pPr marL="0" indent="0" algn="ctr">
              <a:buNone/>
              <a:defRPr sz="3496"/>
            </a:lvl1pPr>
            <a:lvl2pPr marL="666049" indent="0" algn="ctr">
              <a:buNone/>
              <a:defRPr sz="2914"/>
            </a:lvl2pPr>
            <a:lvl3pPr marL="1332098" indent="0" algn="ctr">
              <a:buNone/>
              <a:defRPr sz="2622"/>
            </a:lvl3pPr>
            <a:lvl4pPr marL="1998147" indent="0" algn="ctr">
              <a:buNone/>
              <a:defRPr sz="2331"/>
            </a:lvl4pPr>
            <a:lvl5pPr marL="2664196" indent="0" algn="ctr">
              <a:buNone/>
              <a:defRPr sz="2331"/>
            </a:lvl5pPr>
            <a:lvl6pPr marL="3330245" indent="0" algn="ctr">
              <a:buNone/>
              <a:defRPr sz="2331"/>
            </a:lvl6pPr>
            <a:lvl7pPr marL="3996294" indent="0" algn="ctr">
              <a:buNone/>
              <a:defRPr sz="2331"/>
            </a:lvl7pPr>
            <a:lvl8pPr marL="4662343" indent="0" algn="ctr">
              <a:buNone/>
              <a:defRPr sz="2331"/>
            </a:lvl8pPr>
            <a:lvl9pPr marL="5328392" indent="0" algn="ctr">
              <a:buNone/>
              <a:defRPr sz="233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734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2664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32636" y="575072"/>
            <a:ext cx="2872279" cy="915364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5800" y="575072"/>
            <a:ext cx="8450327" cy="915364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8669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6490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8862" y="2692840"/>
            <a:ext cx="11489115" cy="4493061"/>
          </a:xfrm>
        </p:spPr>
        <p:txBody>
          <a:bodyPr anchor="b"/>
          <a:lstStyle>
            <a:lvl1pPr>
              <a:defRPr sz="874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862" y="7228406"/>
            <a:ext cx="11489115" cy="2362795"/>
          </a:xfrm>
        </p:spPr>
        <p:txBody>
          <a:bodyPr/>
          <a:lstStyle>
            <a:lvl1pPr marL="0" indent="0">
              <a:buNone/>
              <a:defRPr sz="3496">
                <a:solidFill>
                  <a:schemeClr val="tx1"/>
                </a:solidFill>
              </a:defRPr>
            </a:lvl1pPr>
            <a:lvl2pPr marL="666049" indent="0">
              <a:buNone/>
              <a:defRPr sz="2914">
                <a:solidFill>
                  <a:schemeClr val="tx1">
                    <a:tint val="75000"/>
                  </a:schemeClr>
                </a:solidFill>
              </a:defRPr>
            </a:lvl2pPr>
            <a:lvl3pPr marL="1332098" indent="0">
              <a:buNone/>
              <a:defRPr sz="2622">
                <a:solidFill>
                  <a:schemeClr val="tx1">
                    <a:tint val="75000"/>
                  </a:schemeClr>
                </a:solidFill>
              </a:defRPr>
            </a:lvl3pPr>
            <a:lvl4pPr marL="1998147" indent="0">
              <a:buNone/>
              <a:defRPr sz="2331">
                <a:solidFill>
                  <a:schemeClr val="tx1">
                    <a:tint val="75000"/>
                  </a:schemeClr>
                </a:solidFill>
              </a:defRPr>
            </a:lvl4pPr>
            <a:lvl5pPr marL="2664196" indent="0">
              <a:buNone/>
              <a:defRPr sz="2331">
                <a:solidFill>
                  <a:schemeClr val="tx1">
                    <a:tint val="75000"/>
                  </a:schemeClr>
                </a:solidFill>
              </a:defRPr>
            </a:lvl5pPr>
            <a:lvl6pPr marL="3330245" indent="0">
              <a:buNone/>
              <a:defRPr sz="2331">
                <a:solidFill>
                  <a:schemeClr val="tx1">
                    <a:tint val="75000"/>
                  </a:schemeClr>
                </a:solidFill>
              </a:defRPr>
            </a:lvl6pPr>
            <a:lvl7pPr marL="3996294" indent="0">
              <a:buNone/>
              <a:defRPr sz="2331">
                <a:solidFill>
                  <a:schemeClr val="tx1">
                    <a:tint val="75000"/>
                  </a:schemeClr>
                </a:solidFill>
              </a:defRPr>
            </a:lvl7pPr>
            <a:lvl8pPr marL="4662343" indent="0">
              <a:buNone/>
              <a:defRPr sz="2331">
                <a:solidFill>
                  <a:schemeClr val="tx1">
                    <a:tint val="75000"/>
                  </a:schemeClr>
                </a:solidFill>
              </a:defRPr>
            </a:lvl8pPr>
            <a:lvl9pPr marL="5328392" indent="0">
              <a:buNone/>
              <a:defRPr sz="233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8679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5799" y="2875360"/>
            <a:ext cx="5661303" cy="68533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43611" y="2875360"/>
            <a:ext cx="5661303" cy="68533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8615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575074"/>
            <a:ext cx="11489115" cy="20877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7536" y="2647832"/>
            <a:ext cx="5635285" cy="1297661"/>
          </a:xfrm>
        </p:spPr>
        <p:txBody>
          <a:bodyPr anchor="b"/>
          <a:lstStyle>
            <a:lvl1pPr marL="0" indent="0">
              <a:buNone/>
              <a:defRPr sz="3496" b="1"/>
            </a:lvl1pPr>
            <a:lvl2pPr marL="666049" indent="0">
              <a:buNone/>
              <a:defRPr sz="2914" b="1"/>
            </a:lvl2pPr>
            <a:lvl3pPr marL="1332098" indent="0">
              <a:buNone/>
              <a:defRPr sz="2622" b="1"/>
            </a:lvl3pPr>
            <a:lvl4pPr marL="1998147" indent="0">
              <a:buNone/>
              <a:defRPr sz="2331" b="1"/>
            </a:lvl4pPr>
            <a:lvl5pPr marL="2664196" indent="0">
              <a:buNone/>
              <a:defRPr sz="2331" b="1"/>
            </a:lvl5pPr>
            <a:lvl6pPr marL="3330245" indent="0">
              <a:buNone/>
              <a:defRPr sz="2331" b="1"/>
            </a:lvl6pPr>
            <a:lvl7pPr marL="3996294" indent="0">
              <a:buNone/>
              <a:defRPr sz="2331" b="1"/>
            </a:lvl7pPr>
            <a:lvl8pPr marL="4662343" indent="0">
              <a:buNone/>
              <a:defRPr sz="2331" b="1"/>
            </a:lvl8pPr>
            <a:lvl9pPr marL="5328392" indent="0">
              <a:buNone/>
              <a:defRPr sz="233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7536" y="3945493"/>
            <a:ext cx="5635285" cy="580322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43612" y="2647832"/>
            <a:ext cx="5663038" cy="1297661"/>
          </a:xfrm>
        </p:spPr>
        <p:txBody>
          <a:bodyPr anchor="b"/>
          <a:lstStyle>
            <a:lvl1pPr marL="0" indent="0">
              <a:buNone/>
              <a:defRPr sz="3496" b="1"/>
            </a:lvl1pPr>
            <a:lvl2pPr marL="666049" indent="0">
              <a:buNone/>
              <a:defRPr sz="2914" b="1"/>
            </a:lvl2pPr>
            <a:lvl3pPr marL="1332098" indent="0">
              <a:buNone/>
              <a:defRPr sz="2622" b="1"/>
            </a:lvl3pPr>
            <a:lvl4pPr marL="1998147" indent="0">
              <a:buNone/>
              <a:defRPr sz="2331" b="1"/>
            </a:lvl4pPr>
            <a:lvl5pPr marL="2664196" indent="0">
              <a:buNone/>
              <a:defRPr sz="2331" b="1"/>
            </a:lvl5pPr>
            <a:lvl6pPr marL="3330245" indent="0">
              <a:buNone/>
              <a:defRPr sz="2331" b="1"/>
            </a:lvl6pPr>
            <a:lvl7pPr marL="3996294" indent="0">
              <a:buNone/>
              <a:defRPr sz="2331" b="1"/>
            </a:lvl7pPr>
            <a:lvl8pPr marL="4662343" indent="0">
              <a:buNone/>
              <a:defRPr sz="2331" b="1"/>
            </a:lvl8pPr>
            <a:lvl9pPr marL="5328392" indent="0">
              <a:buNone/>
              <a:defRPr sz="233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43612" y="3945493"/>
            <a:ext cx="5663038" cy="580322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792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1430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8323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720090"/>
            <a:ext cx="4296277" cy="2520315"/>
          </a:xfrm>
        </p:spPr>
        <p:txBody>
          <a:bodyPr anchor="b"/>
          <a:lstStyle>
            <a:lvl1pPr>
              <a:defRPr sz="466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63038" y="1555197"/>
            <a:ext cx="6743611" cy="7675959"/>
          </a:xfrm>
        </p:spPr>
        <p:txBody>
          <a:bodyPr/>
          <a:lstStyle>
            <a:lvl1pPr>
              <a:defRPr sz="4662"/>
            </a:lvl1pPr>
            <a:lvl2pPr>
              <a:defRPr sz="4079"/>
            </a:lvl2pPr>
            <a:lvl3pPr>
              <a:defRPr sz="3496"/>
            </a:lvl3pPr>
            <a:lvl4pPr>
              <a:defRPr sz="2914"/>
            </a:lvl4pPr>
            <a:lvl5pPr>
              <a:defRPr sz="2914"/>
            </a:lvl5pPr>
            <a:lvl6pPr>
              <a:defRPr sz="2914"/>
            </a:lvl6pPr>
            <a:lvl7pPr>
              <a:defRPr sz="2914"/>
            </a:lvl7pPr>
            <a:lvl8pPr>
              <a:defRPr sz="2914"/>
            </a:lvl8pPr>
            <a:lvl9pPr>
              <a:defRPr sz="2914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4" y="3240405"/>
            <a:ext cx="4296277" cy="6003251"/>
          </a:xfrm>
        </p:spPr>
        <p:txBody>
          <a:bodyPr/>
          <a:lstStyle>
            <a:lvl1pPr marL="0" indent="0">
              <a:buNone/>
              <a:defRPr sz="2331"/>
            </a:lvl1pPr>
            <a:lvl2pPr marL="666049" indent="0">
              <a:buNone/>
              <a:defRPr sz="2040"/>
            </a:lvl2pPr>
            <a:lvl3pPr marL="1332098" indent="0">
              <a:buNone/>
              <a:defRPr sz="1748"/>
            </a:lvl3pPr>
            <a:lvl4pPr marL="1998147" indent="0">
              <a:buNone/>
              <a:defRPr sz="1457"/>
            </a:lvl4pPr>
            <a:lvl5pPr marL="2664196" indent="0">
              <a:buNone/>
              <a:defRPr sz="1457"/>
            </a:lvl5pPr>
            <a:lvl6pPr marL="3330245" indent="0">
              <a:buNone/>
              <a:defRPr sz="1457"/>
            </a:lvl6pPr>
            <a:lvl7pPr marL="3996294" indent="0">
              <a:buNone/>
              <a:defRPr sz="1457"/>
            </a:lvl7pPr>
            <a:lvl8pPr marL="4662343" indent="0">
              <a:buNone/>
              <a:defRPr sz="1457"/>
            </a:lvl8pPr>
            <a:lvl9pPr marL="5328392" indent="0">
              <a:buNone/>
              <a:defRPr sz="145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3810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720090"/>
            <a:ext cx="4296277" cy="2520315"/>
          </a:xfrm>
        </p:spPr>
        <p:txBody>
          <a:bodyPr anchor="b"/>
          <a:lstStyle>
            <a:lvl1pPr>
              <a:defRPr sz="466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63038" y="1555197"/>
            <a:ext cx="6743611" cy="7675959"/>
          </a:xfrm>
        </p:spPr>
        <p:txBody>
          <a:bodyPr anchor="t"/>
          <a:lstStyle>
            <a:lvl1pPr marL="0" indent="0">
              <a:buNone/>
              <a:defRPr sz="4662"/>
            </a:lvl1pPr>
            <a:lvl2pPr marL="666049" indent="0">
              <a:buNone/>
              <a:defRPr sz="4079"/>
            </a:lvl2pPr>
            <a:lvl3pPr marL="1332098" indent="0">
              <a:buNone/>
              <a:defRPr sz="3496"/>
            </a:lvl3pPr>
            <a:lvl4pPr marL="1998147" indent="0">
              <a:buNone/>
              <a:defRPr sz="2914"/>
            </a:lvl4pPr>
            <a:lvl5pPr marL="2664196" indent="0">
              <a:buNone/>
              <a:defRPr sz="2914"/>
            </a:lvl5pPr>
            <a:lvl6pPr marL="3330245" indent="0">
              <a:buNone/>
              <a:defRPr sz="2914"/>
            </a:lvl6pPr>
            <a:lvl7pPr marL="3996294" indent="0">
              <a:buNone/>
              <a:defRPr sz="2914"/>
            </a:lvl7pPr>
            <a:lvl8pPr marL="4662343" indent="0">
              <a:buNone/>
              <a:defRPr sz="2914"/>
            </a:lvl8pPr>
            <a:lvl9pPr marL="5328392" indent="0">
              <a:buNone/>
              <a:defRPr sz="291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4" y="3240405"/>
            <a:ext cx="4296277" cy="6003251"/>
          </a:xfrm>
        </p:spPr>
        <p:txBody>
          <a:bodyPr/>
          <a:lstStyle>
            <a:lvl1pPr marL="0" indent="0">
              <a:buNone/>
              <a:defRPr sz="2331"/>
            </a:lvl1pPr>
            <a:lvl2pPr marL="666049" indent="0">
              <a:buNone/>
              <a:defRPr sz="2040"/>
            </a:lvl2pPr>
            <a:lvl3pPr marL="1332098" indent="0">
              <a:buNone/>
              <a:defRPr sz="1748"/>
            </a:lvl3pPr>
            <a:lvl4pPr marL="1998147" indent="0">
              <a:buNone/>
              <a:defRPr sz="1457"/>
            </a:lvl4pPr>
            <a:lvl5pPr marL="2664196" indent="0">
              <a:buNone/>
              <a:defRPr sz="1457"/>
            </a:lvl5pPr>
            <a:lvl6pPr marL="3330245" indent="0">
              <a:buNone/>
              <a:defRPr sz="1457"/>
            </a:lvl6pPr>
            <a:lvl7pPr marL="3996294" indent="0">
              <a:buNone/>
              <a:defRPr sz="1457"/>
            </a:lvl7pPr>
            <a:lvl8pPr marL="4662343" indent="0">
              <a:buNone/>
              <a:defRPr sz="1457"/>
            </a:lvl8pPr>
            <a:lvl9pPr marL="5328392" indent="0">
              <a:buNone/>
              <a:defRPr sz="145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832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5799" y="575074"/>
            <a:ext cx="11489115" cy="2087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5799" y="2875360"/>
            <a:ext cx="11489115" cy="68533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5799" y="10011254"/>
            <a:ext cx="299716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12486" y="10011254"/>
            <a:ext cx="4495741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407754" y="10011254"/>
            <a:ext cx="299716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4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7596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332098" rtl="0" eaLnBrk="1" latinLnBrk="0" hangingPunct="1">
        <a:lnSpc>
          <a:spcPct val="90000"/>
        </a:lnSpc>
        <a:spcBef>
          <a:spcPct val="0"/>
        </a:spcBef>
        <a:buNone/>
        <a:defRPr sz="64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3024" indent="-333024" algn="l" defTabSz="1332098" rtl="0" eaLnBrk="1" latinLnBrk="0" hangingPunct="1">
        <a:lnSpc>
          <a:spcPct val="90000"/>
        </a:lnSpc>
        <a:spcBef>
          <a:spcPts val="1457"/>
        </a:spcBef>
        <a:buFont typeface="Arial" panose="020B0604020202020204" pitchFamily="34" charset="0"/>
        <a:buChar char="•"/>
        <a:defRPr sz="4079" kern="1200">
          <a:solidFill>
            <a:schemeClr val="tx1"/>
          </a:solidFill>
          <a:latin typeface="+mn-lt"/>
          <a:ea typeface="+mn-ea"/>
          <a:cs typeface="+mn-cs"/>
        </a:defRPr>
      </a:lvl1pPr>
      <a:lvl2pPr marL="999073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3496" kern="1200">
          <a:solidFill>
            <a:schemeClr val="tx1"/>
          </a:solidFill>
          <a:latin typeface="+mn-lt"/>
          <a:ea typeface="+mn-ea"/>
          <a:cs typeface="+mn-cs"/>
        </a:defRPr>
      </a:lvl2pPr>
      <a:lvl3pPr marL="1665122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914" kern="1200">
          <a:solidFill>
            <a:schemeClr val="tx1"/>
          </a:solidFill>
          <a:latin typeface="+mn-lt"/>
          <a:ea typeface="+mn-ea"/>
          <a:cs typeface="+mn-cs"/>
        </a:defRPr>
      </a:lvl3pPr>
      <a:lvl4pPr marL="2331171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4pPr>
      <a:lvl5pPr marL="2997220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5pPr>
      <a:lvl6pPr marL="3663269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6pPr>
      <a:lvl7pPr marL="4329318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7pPr>
      <a:lvl8pPr marL="4995367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8pPr>
      <a:lvl9pPr marL="5661416" indent="-333024" algn="l" defTabSz="1332098" rtl="0" eaLnBrk="1" latinLnBrk="0" hangingPunct="1">
        <a:lnSpc>
          <a:spcPct val="90000"/>
        </a:lnSpc>
        <a:spcBef>
          <a:spcPts val="728"/>
        </a:spcBef>
        <a:buFont typeface="Arial" panose="020B0604020202020204" pitchFamily="34" charset="0"/>
        <a:buChar char="•"/>
        <a:defRPr sz="262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1pPr>
      <a:lvl2pPr marL="666049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2pPr>
      <a:lvl3pPr marL="1332098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3pPr>
      <a:lvl4pPr marL="1998147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4pPr>
      <a:lvl5pPr marL="2664196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5pPr>
      <a:lvl6pPr marL="3330245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6pPr>
      <a:lvl7pPr marL="3996294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7pPr>
      <a:lvl8pPr marL="4662343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8pPr>
      <a:lvl9pPr marL="5328392" algn="l" defTabSz="1332098" rtl="0" eaLnBrk="1" latinLnBrk="0" hangingPunct="1">
        <a:defRPr sz="262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xmlns="" id="{A24D9DA9-068D-4B5E-985E-010696F1929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4695638"/>
              </p:ext>
            </p:extLst>
          </p:nvPr>
        </p:nvGraphicFramePr>
        <p:xfrm>
          <a:off x="2168742" y="288107"/>
          <a:ext cx="10316501" cy="67296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5154">
                  <a:extLst>
                    <a:ext uri="{9D8B030D-6E8A-4147-A177-3AD203B41FA5}">
                      <a16:colId xmlns:a16="http://schemas.microsoft.com/office/drawing/2014/main" xmlns="" val="214352295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155330355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33445769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148603736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9297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89179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189179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192970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4"/>
                    </a:ext>
                  </a:extLst>
                </a:gridCol>
                <a:gridCol w="192970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6"/>
                    </a:ext>
                  </a:extLst>
                </a:gridCol>
                <a:gridCol w="189179">
                  <a:extLst>
                    <a:ext uri="{9D8B030D-6E8A-4147-A177-3AD203B41FA5}">
                      <a16:colId xmlns:a16="http://schemas.microsoft.com/office/drawing/2014/main" xmlns="" val="2001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8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9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0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4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5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6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8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9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0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4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5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6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1578323557"/>
                    </a:ext>
                  </a:extLst>
                </a:gridCol>
                <a:gridCol w="192970">
                  <a:extLst>
                    <a:ext uri="{9D8B030D-6E8A-4147-A177-3AD203B41FA5}">
                      <a16:colId xmlns:a16="http://schemas.microsoft.com/office/drawing/2014/main" xmlns="" val="140757916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524379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350323105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295637094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366780416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1307583234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51137064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3117467909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642420109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138295204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960260079"/>
                    </a:ext>
                  </a:extLst>
                </a:gridCol>
              </a:tblGrid>
              <a:tr h="6729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M</a:t>
                      </a:r>
                    </a:p>
                  </a:txBody>
                  <a:tcPr marL="8839" marR="8839" marT="15461" marB="0" vert="vert27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6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Palatino Linotype" panose="02040502050505030304" pitchFamily="18" charset="0"/>
                        <a:cs typeface="Times New Roman" pitchFamily="18" charset="0"/>
                      </a:endParaRP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6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7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8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69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0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sng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sng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6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7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sng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8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79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0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7030A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6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7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8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89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0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6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7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8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99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100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sng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10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10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10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V10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M</a:t>
                      </a:r>
                    </a:p>
                  </a:txBody>
                  <a:tcPr marL="8839" marR="8839" marT="15461" marB="0" vert="vert27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8" name="文本框 24">
            <a:extLst>
              <a:ext uri="{FF2B5EF4-FFF2-40B4-BE49-F238E27FC236}">
                <a16:creationId xmlns:a16="http://schemas.microsoft.com/office/drawing/2014/main" xmlns="" id="{877DBEC5-1A2F-497B-B55D-8093ACE189E2}"/>
              </a:ext>
            </a:extLst>
          </p:cNvPr>
          <p:cNvSpPr txBox="1"/>
          <p:nvPr/>
        </p:nvSpPr>
        <p:spPr>
          <a:xfrm>
            <a:off x="683692" y="2737540"/>
            <a:ext cx="148505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id2-ZS</a:t>
            </a:r>
            <a:r>
              <a:rPr lang="en-US" altLang="zh-CN" sz="1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555G</a:t>
            </a:r>
          </a:p>
          <a:p>
            <a:pPr algn="r"/>
            <a:r>
              <a:rPr lang="en-US" altLang="zh-CN" sz="1100">
                <a:latin typeface="Palatino Linotype" panose="02040502050505030304" pitchFamily="18" charset="0"/>
                <a:ea typeface="宋体" panose="02010600030101010101" pitchFamily="2" charset="-122"/>
              </a:rPr>
              <a:t>(111/88 </a:t>
            </a:r>
            <a:r>
              <a:rPr lang="en-US" altLang="zh-CN" sz="1100" dirty="0">
                <a:latin typeface="Palatino Linotype" panose="02040502050505030304" pitchFamily="18" charset="0"/>
                <a:ea typeface="宋体" panose="02010600030101010101" pitchFamily="2" charset="-122"/>
              </a:rPr>
              <a:t>bp)</a:t>
            </a:r>
            <a:endParaRPr lang="zh-CN" altLang="en-US" sz="1100" baseline="30000" dirty="0">
              <a:latin typeface="Palatino Linotype" panose="02040502050505030304" pitchFamily="18" charset="0"/>
              <a:ea typeface="宋体" panose="02010600030101010101" pitchFamily="2" charset="-122"/>
            </a:endParaRPr>
          </a:p>
        </p:txBody>
      </p:sp>
      <p:sp>
        <p:nvSpPr>
          <p:cNvPr id="10" name="文本框 36">
            <a:extLst>
              <a:ext uri="{FF2B5EF4-FFF2-40B4-BE49-F238E27FC236}">
                <a16:creationId xmlns:a16="http://schemas.microsoft.com/office/drawing/2014/main" xmlns="" id="{CE8E89A0-92BC-4E87-A63E-770986395122}"/>
              </a:ext>
            </a:extLst>
          </p:cNvPr>
          <p:cNvSpPr txBox="1"/>
          <p:nvPr/>
        </p:nvSpPr>
        <p:spPr>
          <a:xfrm>
            <a:off x="813372" y="1439655"/>
            <a:ext cx="1390109" cy="431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id2-F/N</a:t>
            </a:r>
            <a:r>
              <a:rPr lang="en-US" altLang="zh-CN" sz="1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1383G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宋体" panose="02010600030101010101" pitchFamily="2" charset="-122"/>
              </a:rPr>
              <a:t>(126/104 bp)</a:t>
            </a:r>
            <a:endParaRPr lang="zh-CN" altLang="en-US" sz="1100" baseline="30000" dirty="0">
              <a:latin typeface="Palatino Linotype" panose="02040502050505030304" pitchFamily="18" charset="0"/>
              <a:ea typeface="宋体" panose="02010600030101010101" pitchFamily="2" charset="-122"/>
            </a:endParaRPr>
          </a:p>
        </p:txBody>
      </p:sp>
      <p:sp>
        <p:nvSpPr>
          <p:cNvPr id="12" name="文本框 53">
            <a:extLst>
              <a:ext uri="{FF2B5EF4-FFF2-40B4-BE49-F238E27FC236}">
                <a16:creationId xmlns:a16="http://schemas.microsoft.com/office/drawing/2014/main" xmlns="" id="{D4493A0F-BF1D-45AB-BB16-F1E00C80E0C6}"/>
              </a:ext>
            </a:extLst>
          </p:cNvPr>
          <p:cNvSpPr txBox="1"/>
          <p:nvPr/>
        </p:nvSpPr>
        <p:spPr>
          <a:xfrm>
            <a:off x="683692" y="2077257"/>
            <a:ext cx="148505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id2-DIG</a:t>
            </a:r>
            <a:r>
              <a:rPr lang="en-US" altLang="zh-CN" sz="1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2058C</a:t>
            </a:r>
          </a:p>
          <a:p>
            <a:pPr algn="r"/>
            <a:r>
              <a:rPr lang="en-US" altLang="zh-CN" sz="1100">
                <a:latin typeface="Palatino Linotype" panose="02040502050505030304" pitchFamily="18" charset="0"/>
                <a:ea typeface="宋体" panose="02010600030101010101" pitchFamily="2" charset="-122"/>
              </a:rPr>
              <a:t>(226/174 </a:t>
            </a:r>
            <a:r>
              <a:rPr lang="en-US" altLang="zh-CN" sz="1100" dirty="0">
                <a:latin typeface="Palatino Linotype" panose="02040502050505030304" pitchFamily="18" charset="0"/>
                <a:ea typeface="宋体" panose="02010600030101010101" pitchFamily="2" charset="-122"/>
              </a:rPr>
              <a:t>bp)</a:t>
            </a:r>
            <a:endParaRPr lang="zh-CN" altLang="en-US" sz="1100" baseline="30000" dirty="0">
              <a:latin typeface="Palatino Linotype" panose="02040502050505030304" pitchFamily="18" charset="0"/>
              <a:ea typeface="宋体" panose="02010600030101010101" pitchFamily="2" charset="-122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xmlns="" id="{15B5ADB5-4C15-41C4-AD1F-DEA51F3146E9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-3000" contrast="-42000"/>
                    </a14:imgEffect>
                  </a14:imgLayer>
                </a14:imgProps>
              </a:ext>
            </a:extLst>
          </a:blip>
          <a:srcRect t="1" r="3827" b="2080"/>
          <a:stretch/>
        </p:blipFill>
        <p:spPr>
          <a:xfrm>
            <a:off x="2203481" y="1457678"/>
            <a:ext cx="5245200" cy="3600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xmlns="" id="{4BBEDDEC-BEEE-4507-91EE-8712FEDF5C94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contrast="-58000"/>
                    </a14:imgEffect>
                  </a14:imgLayer>
                </a14:imgProps>
              </a:ext>
            </a:extLst>
          </a:blip>
          <a:srcRect l="3594" t="890"/>
          <a:stretch/>
        </p:blipFill>
        <p:spPr>
          <a:xfrm>
            <a:off x="7474540" y="1457678"/>
            <a:ext cx="5032800" cy="3600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xmlns="" id="{B222C618-3844-477C-82A7-0A1CEA2DC54A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brightnessContrast bright="-1000" contrast="-35000"/>
                    </a14:imgEffect>
                  </a14:imgLayer>
                </a14:imgProps>
              </a:ext>
            </a:extLst>
          </a:blip>
          <a:srcRect r="3727" b="12459"/>
          <a:stretch/>
        </p:blipFill>
        <p:spPr>
          <a:xfrm>
            <a:off x="2203481" y="2754983"/>
            <a:ext cx="5245200" cy="360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xmlns="" id="{D5110242-A7BB-43E4-AF51-78F47E98274C}"/>
              </a:ext>
            </a:extLst>
          </p:cNvPr>
          <p:cNvPicPr>
            <a:picLocks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4059" t="3756" r="-1"/>
          <a:stretch/>
        </p:blipFill>
        <p:spPr>
          <a:xfrm>
            <a:off x="7474540" y="2754983"/>
            <a:ext cx="5032800" cy="360000"/>
          </a:xfrm>
          <a:prstGeom prst="rect">
            <a:avLst/>
          </a:prstGeom>
        </p:spPr>
      </p:pic>
      <p:sp>
        <p:nvSpPr>
          <p:cNvPr id="19" name="TextBox 27">
            <a:extLst>
              <a:ext uri="{FF2B5EF4-FFF2-40B4-BE49-F238E27FC236}">
                <a16:creationId xmlns:a16="http://schemas.microsoft.com/office/drawing/2014/main" xmlns="" id="{353FDB30-1065-4227-B5F9-719D0B45073D}"/>
              </a:ext>
            </a:extLst>
          </p:cNvPr>
          <p:cNvSpPr txBox="1"/>
          <p:nvPr/>
        </p:nvSpPr>
        <p:spPr>
          <a:xfrm>
            <a:off x="813372" y="5472683"/>
            <a:ext cx="1196766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kern="100" smtClean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400" b="1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2. </a:t>
            </a:r>
            <a:r>
              <a:rPr lang="en-US" altLang="zh-CN" sz="14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llele mining of the </a:t>
            </a:r>
            <a:r>
              <a:rPr lang="en-US" altLang="zh-CN" sz="1400" i="1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id2</a:t>
            </a:r>
            <a:r>
              <a:rPr lang="en-US" altLang="zh-CN" sz="14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lleles in the additional </a:t>
            </a:r>
            <a:r>
              <a:rPr lang="en-US" altLang="zh-CN" sz="1400" i="1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Xian</a:t>
            </a:r>
            <a:r>
              <a:rPr lang="en-US" altLang="zh-CN" sz="14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A to C) and </a:t>
            </a:r>
            <a:r>
              <a:rPr lang="en-US" altLang="zh-CN" sz="1400" i="1" kern="100" dirty="0" err="1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g</a:t>
            </a:r>
            <a:r>
              <a:rPr lang="en-US" altLang="zh-CN" sz="14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D) rice cultivar panels, in the former four </a:t>
            </a:r>
            <a:r>
              <a:rPr lang="en-US" altLang="zh-CN" sz="1400" kern="100" dirty="0" err="1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vs</a:t>
            </a:r>
            <a:r>
              <a:rPr lang="en-US" altLang="zh-CN" sz="14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which were repeated from the regular panel, were ruled out. </a:t>
            </a:r>
            <a:r>
              <a:rPr lang="en-US" altLang="zh-CN" sz="1400" kern="100" dirty="0">
                <a:latin typeface="Palatino Linotype" panose="02040502050505030304" pitchFamily="18" charset="0"/>
              </a:rPr>
              <a:t>CK1, Digu (</a:t>
            </a:r>
            <a:r>
              <a:rPr lang="en-US" altLang="zh-CN" sz="1400" i="1" kern="100" dirty="0">
                <a:latin typeface="Palatino Linotype" panose="02040502050505030304" pitchFamily="18" charset="0"/>
              </a:rPr>
              <a:t>Pid2-</a:t>
            </a:r>
            <a:r>
              <a:rPr lang="en-US" altLang="zh-CN" sz="1400" kern="100" dirty="0">
                <a:latin typeface="Palatino Linotype" panose="02040502050505030304" pitchFamily="18" charset="0"/>
              </a:rPr>
              <a:t>DIG; red); CK2, Tetep (</a:t>
            </a:r>
            <a:r>
              <a:rPr lang="en-US" altLang="zh-CN" sz="1400" i="1" kern="100" dirty="0">
                <a:latin typeface="Palatino Linotype" panose="02040502050505030304" pitchFamily="18" charset="0"/>
              </a:rPr>
              <a:t>Pid2-</a:t>
            </a:r>
            <a:r>
              <a:rPr lang="en-US" altLang="zh-CN" sz="1400" kern="100" dirty="0">
                <a:latin typeface="Palatino Linotype" panose="02040502050505030304" pitchFamily="18" charset="0"/>
              </a:rPr>
              <a:t>ZS; blue); CK3, </a:t>
            </a:r>
            <a:r>
              <a:rPr lang="en-US" altLang="zh-CN" sz="1400" kern="100" dirty="0" err="1">
                <a:latin typeface="Palatino Linotype" panose="02040502050505030304" pitchFamily="18" charset="0"/>
              </a:rPr>
              <a:t>Zhenshan</a:t>
            </a:r>
            <a:r>
              <a:rPr lang="en-US" altLang="zh-CN" sz="1400" kern="100" dirty="0">
                <a:latin typeface="Palatino Linotype" panose="02040502050505030304" pitchFamily="18" charset="0"/>
              </a:rPr>
              <a:t> 97 (</a:t>
            </a:r>
            <a:r>
              <a:rPr lang="en-US" altLang="zh-CN" sz="1400" i="1" kern="100" dirty="0">
                <a:latin typeface="Palatino Linotype" panose="02040502050505030304" pitchFamily="18" charset="0"/>
              </a:rPr>
              <a:t>Pid2-</a:t>
            </a:r>
            <a:r>
              <a:rPr lang="en-US" altLang="zh-CN" sz="1400" kern="100" dirty="0">
                <a:latin typeface="Palatino Linotype" panose="02040502050505030304" pitchFamily="18" charset="0"/>
              </a:rPr>
              <a:t>ZS; blue); CK4, Nipponbare (</a:t>
            </a:r>
            <a:r>
              <a:rPr lang="en-US" altLang="zh-CN" sz="1400" i="1" kern="100" dirty="0">
                <a:latin typeface="Palatino Linotype" panose="02040502050505030304" pitchFamily="18" charset="0"/>
              </a:rPr>
              <a:t>Pid2-</a:t>
            </a:r>
            <a:r>
              <a:rPr lang="en-US" altLang="zh-CN" sz="1400" kern="100" dirty="0">
                <a:latin typeface="Palatino Linotype" panose="02040502050505030304" pitchFamily="18" charset="0"/>
              </a:rPr>
              <a:t>Null; black); CK5, </a:t>
            </a:r>
            <a:r>
              <a:rPr lang="en-US" altLang="zh-CN" sz="1400" kern="100" dirty="0" err="1">
                <a:latin typeface="Palatino Linotype" panose="02040502050505030304" pitchFamily="18" charset="0"/>
              </a:rPr>
              <a:t>Shennong</a:t>
            </a:r>
            <a:r>
              <a:rPr lang="en-US" altLang="zh-CN" sz="1400" kern="100" dirty="0">
                <a:latin typeface="Palatino Linotype" panose="02040502050505030304" pitchFamily="18" charset="0"/>
              </a:rPr>
              <a:t> 265 (</a:t>
            </a:r>
            <a:r>
              <a:rPr lang="en-US" altLang="zh-CN" sz="1400" i="1" kern="100" dirty="0">
                <a:latin typeface="Palatino Linotype" panose="02040502050505030304" pitchFamily="18" charset="0"/>
              </a:rPr>
              <a:t>Pid2-</a:t>
            </a:r>
            <a:r>
              <a:rPr lang="en-US" altLang="zh-CN" sz="1400" kern="100" dirty="0">
                <a:latin typeface="Palatino Linotype" panose="02040502050505030304" pitchFamily="18" charset="0"/>
              </a:rPr>
              <a:t>Null; black); CK6, CO39 (</a:t>
            </a:r>
            <a:r>
              <a:rPr lang="en-US" altLang="zh-CN" sz="1400" i="1" kern="100" dirty="0">
                <a:latin typeface="Palatino Linotype" panose="02040502050505030304" pitchFamily="18" charset="0"/>
              </a:rPr>
              <a:t>Pid2-</a:t>
            </a:r>
            <a:r>
              <a:rPr lang="en-US" altLang="zh-CN" sz="1400" kern="100" dirty="0">
                <a:latin typeface="Palatino Linotype" panose="02040502050505030304" pitchFamily="18" charset="0"/>
              </a:rPr>
              <a:t>ZS; blue); and undefined allele carried by CV86 was marked in purple. M: DL-500 size marker.</a:t>
            </a: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xmlns="" id="{53DBE9A3-A88C-4F58-B9E9-9524D3470840}"/>
              </a:ext>
            </a:extLst>
          </p:cNvPr>
          <p:cNvPicPr>
            <a:picLocks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50000"/>
                    </a14:imgEffect>
                    <a14:imgEffect>
                      <a14:brightnessContrast contrast="-2000"/>
                    </a14:imgEffect>
                  </a14:imgLayer>
                </a14:imgProps>
              </a:ext>
            </a:extLst>
          </a:blip>
          <a:srcRect l="3618" t="2225" b="9285"/>
          <a:stretch/>
        </p:blipFill>
        <p:spPr>
          <a:xfrm>
            <a:off x="7474540" y="2094700"/>
            <a:ext cx="5032800" cy="360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DEE06E65-A29C-4012-BAEE-F0424899DAB0}"/>
              </a:ext>
            </a:extLst>
          </p:cNvPr>
          <p:cNvPicPr>
            <a:picLocks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5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l="292" r="3834"/>
          <a:stretch/>
        </p:blipFill>
        <p:spPr>
          <a:xfrm>
            <a:off x="2203481" y="2094700"/>
            <a:ext cx="5245200" cy="360000"/>
          </a:xfrm>
          <a:prstGeom prst="rect">
            <a:avLst/>
          </a:prstGeom>
        </p:spPr>
      </p:pic>
      <p:graphicFrame>
        <p:nvGraphicFramePr>
          <p:cNvPr id="20" name="表格 19">
            <a:extLst>
              <a:ext uri="{FF2B5EF4-FFF2-40B4-BE49-F238E27FC236}">
                <a16:creationId xmlns:a16="http://schemas.microsoft.com/office/drawing/2014/main" xmlns="" id="{9FDB635C-10C8-E54B-8900-93C78A0AF9F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4260302"/>
              </p:ext>
            </p:extLst>
          </p:nvPr>
        </p:nvGraphicFramePr>
        <p:xfrm>
          <a:off x="2168742" y="3312443"/>
          <a:ext cx="7104458" cy="67296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2564">
                  <a:extLst>
                    <a:ext uri="{9D8B030D-6E8A-4147-A177-3AD203B41FA5}">
                      <a16:colId xmlns:a16="http://schemas.microsoft.com/office/drawing/2014/main" xmlns="" val="2143522951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22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1553303557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334457693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148603736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90409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86669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186669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23"/>
                    </a:ext>
                  </a:extLst>
                </a:gridCol>
                <a:gridCol w="190409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190409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16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19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20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21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24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25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26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27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28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29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30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31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32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33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34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35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36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0037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1578323557"/>
                    </a:ext>
                  </a:extLst>
                </a:gridCol>
                <a:gridCol w="190409">
                  <a:extLst>
                    <a:ext uri="{9D8B030D-6E8A-4147-A177-3AD203B41FA5}">
                      <a16:colId xmlns:a16="http://schemas.microsoft.com/office/drawing/2014/main" xmlns="" val="1407579163"/>
                    </a:ext>
                  </a:extLst>
                </a:gridCol>
                <a:gridCol w="192564">
                  <a:extLst>
                    <a:ext uri="{9D8B030D-6E8A-4147-A177-3AD203B41FA5}">
                      <a16:colId xmlns:a16="http://schemas.microsoft.com/office/drawing/2014/main" xmlns="" val="2960260079"/>
                    </a:ext>
                  </a:extLst>
                </a:gridCol>
              </a:tblGrid>
              <a:tr h="6729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M</a:t>
                      </a:r>
                    </a:p>
                  </a:txBody>
                  <a:tcPr marL="8839" marR="8839" marT="15461" marB="0" vert="vert27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CK6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Palatino Linotype" panose="02040502050505030304" pitchFamily="18" charset="0"/>
                        <a:cs typeface="Times New Roman" pitchFamily="18" charset="0"/>
                      </a:endParaRP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5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6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7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8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9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0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1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2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3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4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5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6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7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8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9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0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1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2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3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4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5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6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7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8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9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30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31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32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K4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itchFamily="18" charset="0"/>
                        </a:rPr>
                        <a:t>M</a:t>
                      </a:r>
                    </a:p>
                  </a:txBody>
                  <a:tcPr marL="8839" marR="8839" marT="15461" marB="0" vert="vert27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22" name="文本框 36">
            <a:extLst>
              <a:ext uri="{FF2B5EF4-FFF2-40B4-BE49-F238E27FC236}">
                <a16:creationId xmlns:a16="http://schemas.microsoft.com/office/drawing/2014/main" xmlns="" id="{D6F2FF86-E76B-2046-9EFE-A98F81FA4DD2}"/>
              </a:ext>
            </a:extLst>
          </p:cNvPr>
          <p:cNvSpPr txBox="1"/>
          <p:nvPr/>
        </p:nvSpPr>
        <p:spPr>
          <a:xfrm>
            <a:off x="813372" y="4411488"/>
            <a:ext cx="135536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id2-F/N</a:t>
            </a:r>
            <a:r>
              <a:rPr lang="en-US" altLang="zh-CN" sz="1100" baseline="30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1383G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宋体" panose="02010600030101010101" pitchFamily="2" charset="-122"/>
              </a:rPr>
              <a:t>(126/104 bp)</a:t>
            </a:r>
            <a:endParaRPr lang="zh-CN" altLang="en-US" sz="1100" baseline="30000" dirty="0">
              <a:latin typeface="Palatino Linotype" panose="02040502050505030304" pitchFamily="18" charset="0"/>
              <a:ea typeface="宋体" panose="02010600030101010101" pitchFamily="2" charset="-122"/>
            </a:endParaRPr>
          </a:p>
        </p:txBody>
      </p:sp>
      <p:sp>
        <p:nvSpPr>
          <p:cNvPr id="23" name="TextBox 6">
            <a:extLst>
              <a:ext uri="{FF2B5EF4-FFF2-40B4-BE49-F238E27FC236}">
                <a16:creationId xmlns:a16="http://schemas.microsoft.com/office/drawing/2014/main" xmlns="" id="{D6315D0A-3B62-9745-9A1A-4EE9966792E2}"/>
              </a:ext>
            </a:extLst>
          </p:cNvPr>
          <p:cNvSpPr txBox="1"/>
          <p:nvPr/>
        </p:nvSpPr>
        <p:spPr>
          <a:xfrm>
            <a:off x="598201" y="792163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6">
            <a:extLst>
              <a:ext uri="{FF2B5EF4-FFF2-40B4-BE49-F238E27FC236}">
                <a16:creationId xmlns:a16="http://schemas.microsoft.com/office/drawing/2014/main" xmlns="" id="{06C84814-CF65-6B45-808A-5C8ECC77D700}"/>
              </a:ext>
            </a:extLst>
          </p:cNvPr>
          <p:cNvSpPr txBox="1"/>
          <p:nvPr/>
        </p:nvSpPr>
        <p:spPr>
          <a:xfrm>
            <a:off x="598201" y="1754109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6">
            <a:extLst>
              <a:ext uri="{FF2B5EF4-FFF2-40B4-BE49-F238E27FC236}">
                <a16:creationId xmlns:a16="http://schemas.microsoft.com/office/drawing/2014/main" xmlns="" id="{B0C1F1BE-5A8F-CF4B-BFEA-CF579572AC74}"/>
              </a:ext>
            </a:extLst>
          </p:cNvPr>
          <p:cNvSpPr txBox="1"/>
          <p:nvPr/>
        </p:nvSpPr>
        <p:spPr>
          <a:xfrm>
            <a:off x="598201" y="2474768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6">
            <a:extLst>
              <a:ext uri="{FF2B5EF4-FFF2-40B4-BE49-F238E27FC236}">
                <a16:creationId xmlns:a16="http://schemas.microsoft.com/office/drawing/2014/main" xmlns="" id="{D2BC989A-3A81-A941-A303-8E25829110BC}"/>
              </a:ext>
            </a:extLst>
          </p:cNvPr>
          <p:cNvSpPr txBox="1"/>
          <p:nvPr/>
        </p:nvSpPr>
        <p:spPr>
          <a:xfrm>
            <a:off x="598201" y="3670502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10AA7F7F-CB35-4981-B6A4-E68D230296F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25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l="443"/>
          <a:stretch/>
        </p:blipFill>
        <p:spPr>
          <a:xfrm>
            <a:off x="2180621" y="4489506"/>
            <a:ext cx="7128000" cy="360000"/>
          </a:xfrm>
          <a:prstGeom prst="rect">
            <a:avLst/>
          </a:prstGeom>
        </p:spPr>
      </p:pic>
      <p:sp>
        <p:nvSpPr>
          <p:cNvPr id="29" name="文本框 19">
            <a:extLst>
              <a:ext uri="{FF2B5EF4-FFF2-40B4-BE49-F238E27FC236}">
                <a16:creationId xmlns:a16="http://schemas.microsoft.com/office/drawing/2014/main" xmlns="" id="{361D6A6F-A5A1-6B48-BFD2-F731D6D98206}"/>
              </a:ext>
            </a:extLst>
          </p:cNvPr>
          <p:cNvSpPr txBox="1"/>
          <p:nvPr/>
        </p:nvSpPr>
        <p:spPr>
          <a:xfrm>
            <a:off x="725888" y="957387"/>
            <a:ext cx="144285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id2-F/N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宋体" pitchFamily="2" charset="-122"/>
              </a:rPr>
              <a:t>C1022T</a:t>
            </a:r>
            <a:endParaRPr lang="en-US" altLang="zh-CN" sz="1100" baseline="30000" dirty="0">
              <a:latin typeface="Palatino Linotype" panose="02040502050505030304" pitchFamily="18" charset="0"/>
              <a:ea typeface="宋体" pitchFamily="2" charset="-122"/>
              <a:cs typeface="Times New Roman" panose="02020603050405020304" pitchFamily="18" charset="0"/>
            </a:endParaRP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宋体" panose="02010600030101010101" pitchFamily="2" charset="-122"/>
              </a:rPr>
              <a:t>(</a:t>
            </a:r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09/85</a:t>
            </a:r>
            <a:r>
              <a:rPr lang="en-US" altLang="zh-CN" sz="1100" dirty="0">
                <a:latin typeface="Palatino Linotype" panose="02040502050505030304" pitchFamily="18" charset="0"/>
                <a:ea typeface="宋体" panose="02010600030101010101" pitchFamily="2" charset="-122"/>
              </a:rPr>
              <a:t> bp)</a:t>
            </a:r>
            <a:endParaRPr lang="zh-CN" altLang="en-US" sz="1100" baseline="30000" dirty="0">
              <a:latin typeface="Palatino Linotype" panose="02040502050505030304" pitchFamily="18" charset="0"/>
              <a:ea typeface="宋体" panose="02010600030101010101" pitchFamily="2" charset="-122"/>
            </a:endParaRPr>
          </a:p>
        </p:txBody>
      </p:sp>
      <p:pic>
        <p:nvPicPr>
          <p:cNvPr id="30" name="Picture 3">
            <a:extLst>
              <a:ext uri="{FF2B5EF4-FFF2-40B4-BE49-F238E27FC236}">
                <a16:creationId xmlns:a16="http://schemas.microsoft.com/office/drawing/2014/main" xmlns="" id="{46526558-E7B3-024A-B98F-38D3F821C638}"/>
              </a:ext>
            </a:extLst>
          </p:cNvPr>
          <p:cNvPicPr>
            <a:picLocks noChangeArrowheads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8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28" b="21549"/>
          <a:stretch/>
        </p:blipFill>
        <p:spPr bwMode="auto">
          <a:xfrm>
            <a:off x="7474540" y="1035364"/>
            <a:ext cx="5032800" cy="3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" name="Picture 4">
            <a:extLst>
              <a:ext uri="{FF2B5EF4-FFF2-40B4-BE49-F238E27FC236}">
                <a16:creationId xmlns:a16="http://schemas.microsoft.com/office/drawing/2014/main" xmlns="" id="{A1A0DE1A-1889-BC4E-B410-CD68E09F6382}"/>
              </a:ext>
            </a:extLst>
          </p:cNvPr>
          <p:cNvPicPr>
            <a:picLocks noChangeArrowheads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17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648" r="3786" b="22488"/>
          <a:stretch/>
        </p:blipFill>
        <p:spPr bwMode="auto">
          <a:xfrm>
            <a:off x="2203481" y="1035364"/>
            <a:ext cx="5245200" cy="3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" name="文本框 19">
            <a:extLst>
              <a:ext uri="{FF2B5EF4-FFF2-40B4-BE49-F238E27FC236}">
                <a16:creationId xmlns:a16="http://schemas.microsoft.com/office/drawing/2014/main" xmlns="" id="{8B25D620-876A-6549-A1E3-B0492C622392}"/>
              </a:ext>
            </a:extLst>
          </p:cNvPr>
          <p:cNvSpPr txBox="1"/>
          <p:nvPr/>
        </p:nvSpPr>
        <p:spPr>
          <a:xfrm>
            <a:off x="725888" y="3968652"/>
            <a:ext cx="144285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id2-F/N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宋体" pitchFamily="2" charset="-122"/>
              </a:rPr>
              <a:t>C1022T</a:t>
            </a:r>
            <a:endParaRPr lang="en-US" altLang="zh-CN" sz="1100" baseline="30000" dirty="0">
              <a:latin typeface="Palatino Linotype" panose="02040502050505030304" pitchFamily="18" charset="0"/>
              <a:ea typeface="宋体" pitchFamily="2" charset="-122"/>
              <a:cs typeface="Times New Roman" panose="02020603050405020304" pitchFamily="18" charset="0"/>
            </a:endParaRP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宋体" panose="02010600030101010101" pitchFamily="2" charset="-122"/>
              </a:rPr>
              <a:t>(</a:t>
            </a:r>
            <a:r>
              <a:rPr lang="en-US" altLang="zh-CN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09/85</a:t>
            </a:r>
            <a:r>
              <a:rPr lang="en-US" altLang="zh-CN" sz="1100" dirty="0">
                <a:latin typeface="Palatino Linotype" panose="02040502050505030304" pitchFamily="18" charset="0"/>
                <a:ea typeface="宋体" panose="02010600030101010101" pitchFamily="2" charset="-122"/>
              </a:rPr>
              <a:t> bp)</a:t>
            </a:r>
            <a:endParaRPr lang="zh-CN" altLang="en-US" sz="1100" baseline="30000" dirty="0">
              <a:latin typeface="Palatino Linotype" panose="02040502050505030304" pitchFamily="18" charset="0"/>
              <a:ea typeface="宋体" panose="02010600030101010101" pitchFamily="2" charset="-122"/>
            </a:endParaRPr>
          </a:p>
        </p:txBody>
      </p:sp>
      <p:pic>
        <p:nvPicPr>
          <p:cNvPr id="33" name="Picture 2">
            <a:extLst>
              <a:ext uri="{FF2B5EF4-FFF2-40B4-BE49-F238E27FC236}">
                <a16:creationId xmlns:a16="http://schemas.microsoft.com/office/drawing/2014/main" xmlns="" id="{326862B2-D347-E84F-BF9F-BF2485DE02DE}"/>
              </a:ext>
            </a:extLst>
          </p:cNvPr>
          <p:cNvPicPr>
            <a:picLocks noChangeArrowheads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harpenSoften amount="5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0621" y="4042947"/>
            <a:ext cx="7128000" cy="3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44491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327</TotalTime>
  <Words>236</Words>
  <Application>Microsoft Office PowerPoint</Application>
  <PresentationFormat>Custom</PresentationFormat>
  <Paragraphs>10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0" baseType="lpstr">
      <vt:lpstr>等线</vt:lpstr>
      <vt:lpstr>等线 Light</vt:lpstr>
      <vt:lpstr>宋体</vt:lpstr>
      <vt:lpstr>Arial</vt:lpstr>
      <vt:lpstr>Calibri</vt:lpstr>
      <vt:lpstr>Calibri Light</vt:lpstr>
      <vt:lpstr>Palatino Linotype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公共</dc:creator>
  <cp:lastModifiedBy>MDPI</cp:lastModifiedBy>
  <cp:revision>2263</cp:revision>
  <cp:lastPrinted>2021-02-15T13:49:48Z</cp:lastPrinted>
  <dcterms:created xsi:type="dcterms:W3CDTF">2018-08-28T01:53:00Z</dcterms:created>
  <dcterms:modified xsi:type="dcterms:W3CDTF">2022-05-17T08:05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698</vt:lpwstr>
  </property>
</Properties>
</file>